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56" autoAdjust="0"/>
  </p:normalViewPr>
  <p:slideViewPr>
    <p:cSldViewPr snapToGrid="0" snapToObjects="1">
      <p:cViewPr>
        <p:scale>
          <a:sx n="90" d="100"/>
          <a:sy n="90" d="100"/>
        </p:scale>
        <p:origin x="-122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9460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9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419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7942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543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929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025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099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9515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743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717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19DD6-667B-4210-BAA3-431B45EAE9CF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47DC1-FE1F-4350-BA22-D864EA4F1EF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971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03410" y="45582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332520" y="45582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337241" y="749824"/>
            <a:ext cx="753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Ha cells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605673" y="756858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eLa </a:t>
            </a:r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ells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519223" y="1280061"/>
            <a:ext cx="516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XIAP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19223" y="1495056"/>
            <a:ext cx="895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OMMD1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714037" y="859063"/>
            <a:ext cx="1875526" cy="484959"/>
            <a:chOff x="714037" y="859063"/>
            <a:chExt cx="1875526" cy="484959"/>
          </a:xfrm>
        </p:grpSpPr>
        <p:sp>
          <p:nvSpPr>
            <p:cNvPr id="22" name="TextBox 21"/>
            <p:cNvSpPr txBox="1"/>
            <p:nvPr/>
          </p:nvSpPr>
          <p:spPr>
            <a:xfrm>
              <a:off x="714037" y="859063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PL 8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18847" y="1033857"/>
              <a:ext cx="8867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G132 2μ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26" name="直接连接符 25"/>
            <p:cNvCxnSpPr/>
            <p:nvPr/>
          </p:nvCxnSpPr>
          <p:spPr>
            <a:xfrm>
              <a:off x="1474646" y="931071"/>
              <a:ext cx="10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2017870" y="1067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017870" y="9110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336231" y="9110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315129" y="1067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474646" y="1067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474646" y="9110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725156" y="9110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746258" y="1067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grpSp>
        <p:nvGrpSpPr>
          <p:cNvPr id="204" name="组合 203"/>
          <p:cNvGrpSpPr/>
          <p:nvPr/>
        </p:nvGrpSpPr>
        <p:grpSpPr>
          <a:xfrm>
            <a:off x="3484966" y="859063"/>
            <a:ext cx="1875526" cy="484959"/>
            <a:chOff x="714037" y="859063"/>
            <a:chExt cx="1875526" cy="484959"/>
          </a:xfrm>
        </p:grpSpPr>
        <p:sp>
          <p:nvSpPr>
            <p:cNvPr id="205" name="TextBox 204"/>
            <p:cNvSpPr txBox="1"/>
            <p:nvPr/>
          </p:nvSpPr>
          <p:spPr>
            <a:xfrm>
              <a:off x="714037" y="859063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PL 4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718847" y="1033857"/>
              <a:ext cx="8867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G132 2μ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207" name="直接连接符 206"/>
            <p:cNvCxnSpPr/>
            <p:nvPr/>
          </p:nvCxnSpPr>
          <p:spPr>
            <a:xfrm>
              <a:off x="1474646" y="931071"/>
              <a:ext cx="10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8" name="TextBox 207"/>
            <p:cNvSpPr txBox="1"/>
            <p:nvPr/>
          </p:nvSpPr>
          <p:spPr>
            <a:xfrm>
              <a:off x="2017870" y="1067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2017870" y="9110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2329197" y="9110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2315129" y="1067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474646" y="1067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1474646" y="9110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1716256" y="9110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+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1746258" y="1067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</a:t>
              </a:r>
              <a:endParaRPr lang="zh-CN" altLang="en-US" sz="12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216" name="TextBox 215"/>
          <p:cNvSpPr txBox="1"/>
          <p:nvPr/>
        </p:nvSpPr>
        <p:spPr>
          <a:xfrm>
            <a:off x="5311254" y="1280060"/>
            <a:ext cx="516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XIAP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5311254" y="1495055"/>
            <a:ext cx="786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OMMD1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5311254" y="1741277"/>
            <a:ext cx="786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GAPDH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62" name="Picture 7" descr="E:\2024-6-7\3-2-COMMD1-2.Tif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57" t="42806" r="45175" b="47764"/>
          <a:stretch/>
        </p:blipFill>
        <p:spPr bwMode="auto">
          <a:xfrm>
            <a:off x="4288003" y="1550883"/>
            <a:ext cx="10800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21" descr="E:\2024-5-30\8-XIAP.Tif"/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61" t="62793" r="45976" b="30303"/>
          <a:stretch/>
        </p:blipFill>
        <p:spPr bwMode="auto">
          <a:xfrm>
            <a:off x="4282399" y="1315056"/>
            <a:ext cx="10800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15" descr="E:\2024-6-6\8-2-GAPDH.Tif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52" t="56316" r="41539" b="36313"/>
          <a:stretch/>
        </p:blipFill>
        <p:spPr bwMode="auto">
          <a:xfrm>
            <a:off x="4289433" y="1791193"/>
            <a:ext cx="10800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6" descr="E:\2024-05-WB\2024-5-23\2-XIAP-2.Tif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30" t="42284" r="41228" b="50135"/>
          <a:stretch/>
        </p:blipFill>
        <p:spPr bwMode="auto">
          <a:xfrm>
            <a:off x="1479972" y="1313170"/>
            <a:ext cx="10800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0" t="25275" r="34598" b="18406"/>
          <a:stretch/>
        </p:blipFill>
        <p:spPr>
          <a:xfrm>
            <a:off x="1479972" y="1561277"/>
            <a:ext cx="108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3" descr="E:\2024-6-3\1-GAPDH.Tif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36" t="68247" r="46013" b="26388"/>
          <a:stretch/>
        </p:blipFill>
        <p:spPr bwMode="auto">
          <a:xfrm>
            <a:off x="1474646" y="1791193"/>
            <a:ext cx="10800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0" name="TextBox 69"/>
          <p:cNvSpPr txBox="1"/>
          <p:nvPr/>
        </p:nvSpPr>
        <p:spPr>
          <a:xfrm>
            <a:off x="2519223" y="1741277"/>
            <a:ext cx="786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GAPDH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03410" y="211350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03410" y="465975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D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410" y="2342674"/>
            <a:ext cx="3669792" cy="253136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410" y="5035817"/>
            <a:ext cx="3669792" cy="2531364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1605628" y="2353209"/>
            <a:ext cx="4892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eLa</a:t>
            </a:r>
            <a:endParaRPr lang="zh-CN" altLang="en-US" sz="1000"/>
          </a:p>
        </p:txBody>
      </p:sp>
      <p:sp>
        <p:nvSpPr>
          <p:cNvPr id="10" name="矩形 9"/>
          <p:cNvSpPr/>
          <p:nvPr/>
        </p:nvSpPr>
        <p:spPr>
          <a:xfrm>
            <a:off x="1633246" y="5016765"/>
            <a:ext cx="4619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Ha</a:t>
            </a:r>
            <a:endParaRPr lang="zh-CN" altLang="en-US" sz="1000"/>
          </a:p>
        </p:txBody>
      </p:sp>
      <p:cxnSp>
        <p:nvCxnSpPr>
          <p:cNvPr id="11" name="直接连接符 10"/>
          <p:cNvCxnSpPr/>
          <p:nvPr/>
        </p:nvCxnSpPr>
        <p:spPr>
          <a:xfrm>
            <a:off x="1420837" y="3756074"/>
            <a:ext cx="2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370357" y="3559122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ns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382077" y="6300034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ns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2" name="直接连接符 51"/>
          <p:cNvCxnSpPr/>
          <p:nvPr/>
        </p:nvCxnSpPr>
        <p:spPr>
          <a:xfrm>
            <a:off x="1417809" y="6482862"/>
            <a:ext cx="2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>
            <a:off x="2245246" y="5484055"/>
            <a:ext cx="2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2242447" y="2667425"/>
            <a:ext cx="2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2231215" y="530582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#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195219" y="2476282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##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907131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44</Words>
  <Application>Microsoft Office PowerPoint</Application>
  <PresentationFormat>全屏显示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6</cp:revision>
  <dcterms:created xsi:type="dcterms:W3CDTF">2024-02-29T09:15:58Z</dcterms:created>
  <dcterms:modified xsi:type="dcterms:W3CDTF">2024-06-28T11:41:46Z</dcterms:modified>
</cp:coreProperties>
</file>